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png" ContentType="image/pn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1703050" cy="64008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4F8E58-DF0F-4B49-8A72-3740C0F7285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85360" y="255240"/>
            <a:ext cx="10533240" cy="106668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85360" y="1494000"/>
            <a:ext cx="10533240" cy="20149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85360" y="3700800"/>
            <a:ext cx="10533240" cy="20149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89EA11-6304-4068-8645-AD58A2A9BD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85360" y="255240"/>
            <a:ext cx="10533240" cy="106668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85360" y="1494000"/>
            <a:ext cx="5140080" cy="20149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982840" y="1494000"/>
            <a:ext cx="5140080" cy="20149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85360" y="3700800"/>
            <a:ext cx="5140080" cy="20149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982840" y="3700800"/>
            <a:ext cx="5140080" cy="20149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B0565D-3DC9-460C-A642-95252E0B12E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85360" y="255240"/>
            <a:ext cx="10533240" cy="106668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85360" y="1494000"/>
            <a:ext cx="3391560" cy="20149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146840" y="1494000"/>
            <a:ext cx="3391560" cy="20149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708320" y="1494000"/>
            <a:ext cx="3391560" cy="20149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85360" y="3700800"/>
            <a:ext cx="3391560" cy="20149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146840" y="3700800"/>
            <a:ext cx="3391560" cy="20149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708320" y="3700800"/>
            <a:ext cx="3391560" cy="20149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1BD18F-9368-4094-8D52-244CA527CF3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85360" y="255240"/>
            <a:ext cx="10533240" cy="106668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85360" y="1494000"/>
            <a:ext cx="10533240" cy="4224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95F9EE-223B-4D52-88B3-A9EA6F0A60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85360" y="255240"/>
            <a:ext cx="10533240" cy="106668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85360" y="1494000"/>
            <a:ext cx="10533240" cy="422424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A7359F-7364-4D8A-8E38-1F9C7AA9F2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85360" y="255240"/>
            <a:ext cx="10533240" cy="106668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85360" y="1494000"/>
            <a:ext cx="5140080" cy="422424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982840" y="1494000"/>
            <a:ext cx="5140080" cy="422424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59BF1E-B6FA-4AB1-B558-C0370ABC79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85360" y="255240"/>
            <a:ext cx="10533240" cy="106668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C9F2A2-BCF3-4714-AED9-CE4CCBB8C7C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85360" y="255240"/>
            <a:ext cx="10533240" cy="494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00"/>
              </a:spcBef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FA32F8-52C5-45A3-BA50-002D9E3FCB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85360" y="255240"/>
            <a:ext cx="10533240" cy="106668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85360" y="1494000"/>
            <a:ext cx="5140080" cy="20149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982840" y="1494000"/>
            <a:ext cx="5140080" cy="422424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85360" y="3700800"/>
            <a:ext cx="5140080" cy="20149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1B2873-DE7D-4D71-AB99-CF6F14E3D5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85360" y="255240"/>
            <a:ext cx="10533240" cy="106668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85360" y="1494000"/>
            <a:ext cx="5140080" cy="422424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982840" y="1494000"/>
            <a:ext cx="5140080" cy="20149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982840" y="3700800"/>
            <a:ext cx="5140080" cy="20149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3CEF80-783E-490B-8D5E-9DB987A55F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85360" y="255240"/>
            <a:ext cx="10533240" cy="106668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85360" y="1494000"/>
            <a:ext cx="5140080" cy="20149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982840" y="1494000"/>
            <a:ext cx="5140080" cy="20149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85360" y="3700800"/>
            <a:ext cx="10533240" cy="20149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D1C7A7-C2FD-480E-AA84-4B2E98F339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85360" y="255240"/>
            <a:ext cx="10533240" cy="106668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3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85360" y="1494000"/>
            <a:ext cx="10533240" cy="422424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marL="298440" indent="-29844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49440" indent="-24948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998640" indent="-19836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398600" indent="-19836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1797120" indent="-19836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1797120" indent="-19836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1797120" indent="-19836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85360" y="5932440"/>
            <a:ext cx="2730600" cy="34128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  <a:defRPr b="0" lang="en-US" sz="11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fld id="{23BE0056-B752-4939-9AC6-726B282A6B9A}" type="datetime">
              <a:rPr b="0" lang="en-US" sz="11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998520" y="5932440"/>
            <a:ext cx="3706920" cy="34128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>
              <a:buNone/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388000" y="5932440"/>
            <a:ext cx="2730600" cy="34128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  <a:defRPr b="0" lang="en-US" sz="11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fld id="{09FDADAB-990A-4650-86C3-71D0D976ACF4}" type="slidenum">
              <a:rPr b="0" lang="en-US" sz="11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n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Straight Connector 209"/>
          <p:cNvSpPr/>
          <p:nvPr/>
        </p:nvSpPr>
        <p:spPr>
          <a:xfrm>
            <a:off x="4781520" y="633240"/>
            <a:ext cx="9216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Straight Connector 210"/>
          <p:cNvSpPr/>
          <p:nvPr/>
        </p:nvSpPr>
        <p:spPr>
          <a:xfrm>
            <a:off x="4781520" y="1746360"/>
            <a:ext cx="9216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Straight Connector 211"/>
          <p:cNvSpPr/>
          <p:nvPr/>
        </p:nvSpPr>
        <p:spPr>
          <a:xfrm>
            <a:off x="4781520" y="2116080"/>
            <a:ext cx="9216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Straight Connector 212"/>
          <p:cNvSpPr/>
          <p:nvPr/>
        </p:nvSpPr>
        <p:spPr>
          <a:xfrm>
            <a:off x="4781520" y="1374840"/>
            <a:ext cx="9216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Straight Connector 213"/>
          <p:cNvSpPr/>
          <p:nvPr/>
        </p:nvSpPr>
        <p:spPr>
          <a:xfrm>
            <a:off x="4781520" y="2487600"/>
            <a:ext cx="9216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Straight Connector 215"/>
          <p:cNvSpPr/>
          <p:nvPr/>
        </p:nvSpPr>
        <p:spPr>
          <a:xfrm>
            <a:off x="4781520" y="1004760"/>
            <a:ext cx="9216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Straight Connector 216"/>
          <p:cNvSpPr/>
          <p:nvPr/>
        </p:nvSpPr>
        <p:spPr>
          <a:xfrm>
            <a:off x="11293560" y="345960"/>
            <a:ext cx="9216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Straight Connector 217"/>
          <p:cNvSpPr/>
          <p:nvPr/>
        </p:nvSpPr>
        <p:spPr>
          <a:xfrm>
            <a:off x="11293560" y="608040"/>
            <a:ext cx="9216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Straight Connector 218"/>
          <p:cNvSpPr/>
          <p:nvPr/>
        </p:nvSpPr>
        <p:spPr>
          <a:xfrm>
            <a:off x="11293560" y="1652760"/>
            <a:ext cx="9216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Straight Connector 219"/>
          <p:cNvSpPr/>
          <p:nvPr/>
        </p:nvSpPr>
        <p:spPr>
          <a:xfrm>
            <a:off x="11293560" y="2174760"/>
            <a:ext cx="9216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Straight Connector 220"/>
          <p:cNvSpPr/>
          <p:nvPr/>
        </p:nvSpPr>
        <p:spPr>
          <a:xfrm>
            <a:off x="11293560" y="1130400"/>
            <a:ext cx="9216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Straight Connector 221"/>
          <p:cNvSpPr/>
          <p:nvPr/>
        </p:nvSpPr>
        <p:spPr>
          <a:xfrm>
            <a:off x="11306160" y="2697120"/>
            <a:ext cx="9216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Straight Connector 222"/>
          <p:cNvSpPr/>
          <p:nvPr/>
        </p:nvSpPr>
        <p:spPr>
          <a:xfrm>
            <a:off x="11293560" y="868320"/>
            <a:ext cx="9216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Straight Connector 223"/>
          <p:cNvSpPr/>
          <p:nvPr/>
        </p:nvSpPr>
        <p:spPr>
          <a:xfrm>
            <a:off x="11293560" y="1913040"/>
            <a:ext cx="9216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Straight Connector 224"/>
          <p:cNvSpPr/>
          <p:nvPr/>
        </p:nvSpPr>
        <p:spPr>
          <a:xfrm>
            <a:off x="11293560" y="2436840"/>
            <a:ext cx="9216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Straight Connector 225"/>
          <p:cNvSpPr/>
          <p:nvPr/>
        </p:nvSpPr>
        <p:spPr>
          <a:xfrm>
            <a:off x="11293560" y="1390680"/>
            <a:ext cx="9216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Straight Connector 226"/>
          <p:cNvSpPr/>
          <p:nvPr/>
        </p:nvSpPr>
        <p:spPr>
          <a:xfrm flipV="1">
            <a:off x="11325240" y="2706480"/>
            <a:ext cx="1440" cy="9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4"/>
          <p:cNvSpPr/>
          <p:nvPr/>
        </p:nvSpPr>
        <p:spPr>
          <a:xfrm>
            <a:off x="11552400" y="252108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17"/>
          <p:cNvSpPr/>
          <p:nvPr/>
        </p:nvSpPr>
        <p:spPr>
          <a:xfrm>
            <a:off x="11423880" y="148752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17"/>
          <p:cNvSpPr/>
          <p:nvPr/>
        </p:nvSpPr>
        <p:spPr>
          <a:xfrm>
            <a:off x="11423880" y="201132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17"/>
          <p:cNvSpPr/>
          <p:nvPr/>
        </p:nvSpPr>
        <p:spPr>
          <a:xfrm>
            <a:off x="11423880" y="122544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17"/>
          <p:cNvSpPr/>
          <p:nvPr/>
        </p:nvSpPr>
        <p:spPr>
          <a:xfrm>
            <a:off x="11423880" y="174960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17"/>
          <p:cNvSpPr/>
          <p:nvPr/>
        </p:nvSpPr>
        <p:spPr>
          <a:xfrm>
            <a:off x="11423880" y="227160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17"/>
          <p:cNvSpPr/>
          <p:nvPr/>
        </p:nvSpPr>
        <p:spPr>
          <a:xfrm>
            <a:off x="11423880" y="44136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17"/>
          <p:cNvSpPr/>
          <p:nvPr/>
        </p:nvSpPr>
        <p:spPr>
          <a:xfrm>
            <a:off x="11423880" y="96516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17"/>
          <p:cNvSpPr/>
          <p:nvPr/>
        </p:nvSpPr>
        <p:spPr>
          <a:xfrm>
            <a:off x="11423880" y="18108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17"/>
          <p:cNvSpPr/>
          <p:nvPr/>
        </p:nvSpPr>
        <p:spPr>
          <a:xfrm>
            <a:off x="11423880" y="70344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Straight Connector 237"/>
          <p:cNvSpPr/>
          <p:nvPr/>
        </p:nvSpPr>
        <p:spPr>
          <a:xfrm>
            <a:off x="3720960" y="225360"/>
            <a:ext cx="92160" cy="1800"/>
          </a:xfrm>
          <a:prstGeom prst="line">
            <a:avLst/>
          </a:prstGeom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Straight Connector 238"/>
          <p:cNvSpPr/>
          <p:nvPr/>
        </p:nvSpPr>
        <p:spPr>
          <a:xfrm>
            <a:off x="3720960" y="703440"/>
            <a:ext cx="92160" cy="1440"/>
          </a:xfrm>
          <a:prstGeom prst="line">
            <a:avLst/>
          </a:prstGeom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Straight Connector 239"/>
          <p:cNvSpPr/>
          <p:nvPr/>
        </p:nvSpPr>
        <p:spPr>
          <a:xfrm>
            <a:off x="3720960" y="1182600"/>
            <a:ext cx="92160" cy="1800"/>
          </a:xfrm>
          <a:prstGeom prst="line">
            <a:avLst/>
          </a:prstGeom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Straight Connector 240"/>
          <p:cNvSpPr/>
          <p:nvPr/>
        </p:nvSpPr>
        <p:spPr>
          <a:xfrm>
            <a:off x="3720960" y="2138400"/>
            <a:ext cx="92160" cy="1440"/>
          </a:xfrm>
          <a:prstGeom prst="line">
            <a:avLst/>
          </a:prstGeom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Straight Connector 241"/>
          <p:cNvSpPr/>
          <p:nvPr/>
        </p:nvSpPr>
        <p:spPr>
          <a:xfrm>
            <a:off x="3720960" y="1660680"/>
            <a:ext cx="92160" cy="1440"/>
          </a:xfrm>
          <a:prstGeom prst="line">
            <a:avLst/>
          </a:prstGeom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24"/>
          <p:cNvSpPr/>
          <p:nvPr/>
        </p:nvSpPr>
        <p:spPr>
          <a:xfrm>
            <a:off x="47520" y="248760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0.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19"/>
          <p:cNvSpPr/>
          <p:nvPr/>
        </p:nvSpPr>
        <p:spPr>
          <a:xfrm>
            <a:off x="3836880" y="6048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0.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20"/>
          <p:cNvSpPr/>
          <p:nvPr/>
        </p:nvSpPr>
        <p:spPr>
          <a:xfrm>
            <a:off x="3836880" y="53820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0.4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21"/>
          <p:cNvSpPr/>
          <p:nvPr/>
        </p:nvSpPr>
        <p:spPr>
          <a:xfrm>
            <a:off x="3836880" y="101772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0.3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22"/>
          <p:cNvSpPr/>
          <p:nvPr/>
        </p:nvSpPr>
        <p:spPr>
          <a:xfrm>
            <a:off x="3836880" y="149544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0.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23"/>
          <p:cNvSpPr/>
          <p:nvPr/>
        </p:nvSpPr>
        <p:spPr>
          <a:xfrm>
            <a:off x="3836880" y="197496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0.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24"/>
          <p:cNvSpPr/>
          <p:nvPr/>
        </p:nvSpPr>
        <p:spPr>
          <a:xfrm>
            <a:off x="3836880" y="245268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0.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Straight Connector 249"/>
          <p:cNvSpPr/>
          <p:nvPr/>
        </p:nvSpPr>
        <p:spPr>
          <a:xfrm>
            <a:off x="372960" y="428760"/>
            <a:ext cx="92160" cy="1440"/>
          </a:xfrm>
          <a:prstGeom prst="line">
            <a:avLst/>
          </a:prstGeom>
          <a:ln w="255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Straight Connector 250"/>
          <p:cNvSpPr/>
          <p:nvPr/>
        </p:nvSpPr>
        <p:spPr>
          <a:xfrm>
            <a:off x="372960" y="873000"/>
            <a:ext cx="92160" cy="1800"/>
          </a:xfrm>
          <a:prstGeom prst="line">
            <a:avLst/>
          </a:prstGeom>
          <a:ln w="255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Straight Connector 251"/>
          <p:cNvSpPr/>
          <p:nvPr/>
        </p:nvSpPr>
        <p:spPr>
          <a:xfrm>
            <a:off x="372960" y="1763640"/>
            <a:ext cx="92160" cy="1800"/>
          </a:xfrm>
          <a:prstGeom prst="line">
            <a:avLst/>
          </a:prstGeom>
          <a:ln w="255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Straight Connector 252"/>
          <p:cNvSpPr/>
          <p:nvPr/>
        </p:nvSpPr>
        <p:spPr>
          <a:xfrm>
            <a:off x="372960" y="2208240"/>
            <a:ext cx="92160" cy="1440"/>
          </a:xfrm>
          <a:prstGeom prst="line">
            <a:avLst/>
          </a:prstGeom>
          <a:ln w="255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Straight Connector 253"/>
          <p:cNvSpPr/>
          <p:nvPr/>
        </p:nvSpPr>
        <p:spPr>
          <a:xfrm>
            <a:off x="372960" y="1319040"/>
            <a:ext cx="92160" cy="1800"/>
          </a:xfrm>
          <a:prstGeom prst="line">
            <a:avLst/>
          </a:prstGeom>
          <a:ln w="255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Straight Connector 254"/>
          <p:cNvSpPr/>
          <p:nvPr/>
        </p:nvSpPr>
        <p:spPr>
          <a:xfrm>
            <a:off x="372960" y="2652840"/>
            <a:ext cx="92160" cy="1440"/>
          </a:xfrm>
          <a:prstGeom prst="line">
            <a:avLst/>
          </a:prstGeom>
          <a:ln w="255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17"/>
          <p:cNvSpPr/>
          <p:nvPr/>
        </p:nvSpPr>
        <p:spPr>
          <a:xfrm>
            <a:off x="47520" y="70632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2.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17"/>
          <p:cNvSpPr/>
          <p:nvPr/>
        </p:nvSpPr>
        <p:spPr>
          <a:xfrm>
            <a:off x="47520" y="159696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1.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17"/>
          <p:cNvSpPr/>
          <p:nvPr/>
        </p:nvSpPr>
        <p:spPr>
          <a:xfrm>
            <a:off x="47520" y="26028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2.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17"/>
          <p:cNvSpPr/>
          <p:nvPr/>
        </p:nvSpPr>
        <p:spPr>
          <a:xfrm>
            <a:off x="47520" y="115092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1.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17"/>
          <p:cNvSpPr/>
          <p:nvPr/>
        </p:nvSpPr>
        <p:spPr>
          <a:xfrm>
            <a:off x="47520" y="204300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ff"/>
                </a:solidFill>
                <a:latin typeface="Times New Roman"/>
                <a:ea typeface="Times New Roman"/>
              </a:rPr>
              <a:t>0.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Straight Connector 260"/>
          <p:cNvSpPr/>
          <p:nvPr/>
        </p:nvSpPr>
        <p:spPr>
          <a:xfrm flipV="1">
            <a:off x="571680" y="2706480"/>
            <a:ext cx="1440" cy="9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Straight Connector 261"/>
          <p:cNvSpPr/>
          <p:nvPr/>
        </p:nvSpPr>
        <p:spPr>
          <a:xfrm flipV="1">
            <a:off x="1365120" y="2706480"/>
            <a:ext cx="1800" cy="9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Straight Connector 262"/>
          <p:cNvSpPr/>
          <p:nvPr/>
        </p:nvSpPr>
        <p:spPr>
          <a:xfrm flipV="1">
            <a:off x="2155680" y="2706480"/>
            <a:ext cx="1800" cy="9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Straight Connector 263"/>
          <p:cNvSpPr/>
          <p:nvPr/>
        </p:nvSpPr>
        <p:spPr>
          <a:xfrm flipV="1">
            <a:off x="2948040" y="2706480"/>
            <a:ext cx="1440" cy="9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19"/>
          <p:cNvSpPr/>
          <p:nvPr/>
        </p:nvSpPr>
        <p:spPr>
          <a:xfrm>
            <a:off x="441360" y="274788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20"/>
          <p:cNvSpPr/>
          <p:nvPr/>
        </p:nvSpPr>
        <p:spPr>
          <a:xfrm>
            <a:off x="1242720" y="274788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21"/>
          <p:cNvSpPr/>
          <p:nvPr/>
        </p:nvSpPr>
        <p:spPr>
          <a:xfrm>
            <a:off x="2030400" y="274788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22"/>
          <p:cNvSpPr/>
          <p:nvPr/>
        </p:nvSpPr>
        <p:spPr>
          <a:xfrm>
            <a:off x="2822760" y="274788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23"/>
          <p:cNvSpPr/>
          <p:nvPr/>
        </p:nvSpPr>
        <p:spPr>
          <a:xfrm>
            <a:off x="3623760" y="274788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00" name="Object 2"/>
          <p:cNvGraphicFramePr/>
          <p:nvPr/>
        </p:nvGraphicFramePr>
        <p:xfrm>
          <a:off x="444600" y="31680"/>
          <a:ext cx="3308400" cy="26910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101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44600" y="31680"/>
                    <a:ext cx="3308400" cy="2691000"/>
                  </a:xfrm>
                  <a:prstGeom prst="rect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102" name="Straight Connector 270"/>
          <p:cNvSpPr/>
          <p:nvPr/>
        </p:nvSpPr>
        <p:spPr>
          <a:xfrm>
            <a:off x="3720960" y="2603520"/>
            <a:ext cx="92160" cy="1440"/>
          </a:xfrm>
          <a:prstGeom prst="line">
            <a:avLst/>
          </a:prstGeom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Straight Connector 271"/>
          <p:cNvSpPr/>
          <p:nvPr/>
        </p:nvSpPr>
        <p:spPr>
          <a:xfrm flipV="1">
            <a:off x="5311800" y="2706480"/>
            <a:ext cx="1440" cy="9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Straight Connector 272"/>
          <p:cNvSpPr/>
          <p:nvPr/>
        </p:nvSpPr>
        <p:spPr>
          <a:xfrm flipV="1">
            <a:off x="5913360" y="2706480"/>
            <a:ext cx="1800" cy="9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Straight Connector 273"/>
          <p:cNvSpPr/>
          <p:nvPr/>
        </p:nvSpPr>
        <p:spPr>
          <a:xfrm flipV="1">
            <a:off x="6515280" y="2706480"/>
            <a:ext cx="1440" cy="9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Straight Connector 274"/>
          <p:cNvSpPr/>
          <p:nvPr/>
        </p:nvSpPr>
        <p:spPr>
          <a:xfrm flipV="1">
            <a:off x="7115040" y="2706480"/>
            <a:ext cx="1800" cy="9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Straight Connector 275"/>
          <p:cNvSpPr/>
          <p:nvPr/>
        </p:nvSpPr>
        <p:spPr>
          <a:xfrm flipV="1">
            <a:off x="7716960" y="2706480"/>
            <a:ext cx="1440" cy="9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Straight Connector 276"/>
          <p:cNvSpPr/>
          <p:nvPr/>
        </p:nvSpPr>
        <p:spPr>
          <a:xfrm flipV="1">
            <a:off x="8318520" y="2706480"/>
            <a:ext cx="1440" cy="9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Straight Connector 277"/>
          <p:cNvSpPr/>
          <p:nvPr/>
        </p:nvSpPr>
        <p:spPr>
          <a:xfrm flipV="1">
            <a:off x="8920080" y="2706480"/>
            <a:ext cx="1800" cy="9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Straight Connector 278"/>
          <p:cNvSpPr/>
          <p:nvPr/>
        </p:nvSpPr>
        <p:spPr>
          <a:xfrm flipV="1">
            <a:off x="9522000" y="2706480"/>
            <a:ext cx="1440" cy="9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Straight Connector 279"/>
          <p:cNvSpPr/>
          <p:nvPr/>
        </p:nvSpPr>
        <p:spPr>
          <a:xfrm flipV="1">
            <a:off x="10121760" y="2706480"/>
            <a:ext cx="1800" cy="9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Straight Connector 280"/>
          <p:cNvSpPr/>
          <p:nvPr/>
        </p:nvSpPr>
        <p:spPr>
          <a:xfrm flipV="1">
            <a:off x="10723680" y="2706480"/>
            <a:ext cx="1440" cy="9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 Box 19"/>
          <p:cNvSpPr/>
          <p:nvPr/>
        </p:nvSpPr>
        <p:spPr>
          <a:xfrm>
            <a:off x="5189040" y="274788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 Box 20"/>
          <p:cNvSpPr/>
          <p:nvPr/>
        </p:nvSpPr>
        <p:spPr>
          <a:xfrm>
            <a:off x="6391080" y="274788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 Box 21"/>
          <p:cNvSpPr/>
          <p:nvPr/>
        </p:nvSpPr>
        <p:spPr>
          <a:xfrm>
            <a:off x="7592760" y="274788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 Box 22"/>
          <p:cNvSpPr/>
          <p:nvPr/>
        </p:nvSpPr>
        <p:spPr>
          <a:xfrm>
            <a:off x="8794800" y="274788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 Box 23"/>
          <p:cNvSpPr/>
          <p:nvPr/>
        </p:nvSpPr>
        <p:spPr>
          <a:xfrm>
            <a:off x="9996480" y="274788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 Box 20"/>
          <p:cNvSpPr/>
          <p:nvPr/>
        </p:nvSpPr>
        <p:spPr>
          <a:xfrm>
            <a:off x="6991560" y="274788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21"/>
          <p:cNvSpPr/>
          <p:nvPr/>
        </p:nvSpPr>
        <p:spPr>
          <a:xfrm>
            <a:off x="8193240" y="274788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 Box 22"/>
          <p:cNvSpPr/>
          <p:nvPr/>
        </p:nvSpPr>
        <p:spPr>
          <a:xfrm>
            <a:off x="9396000" y="274788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 Box 23"/>
          <p:cNvSpPr/>
          <p:nvPr/>
        </p:nvSpPr>
        <p:spPr>
          <a:xfrm>
            <a:off x="10597680" y="274788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 Box 23"/>
          <p:cNvSpPr/>
          <p:nvPr/>
        </p:nvSpPr>
        <p:spPr>
          <a:xfrm>
            <a:off x="5789880" y="274788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Straight Connector 291"/>
          <p:cNvSpPr/>
          <p:nvPr/>
        </p:nvSpPr>
        <p:spPr>
          <a:xfrm flipV="1">
            <a:off x="3743280" y="2706480"/>
            <a:ext cx="1800" cy="9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Line 32"/>
          <p:cNvSpPr/>
          <p:nvPr/>
        </p:nvSpPr>
        <p:spPr>
          <a:xfrm>
            <a:off x="10132920" y="1419120"/>
            <a:ext cx="358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5" name="Picture 2" descr="DSP30mg-Pronase-G15-1"/>
          <p:cNvPicPr/>
          <p:nvPr/>
        </p:nvPicPr>
        <p:blipFill>
          <a:blip r:embed="rId3"/>
          <a:srcRect l="15299" t="2362" r="6682" b="5135"/>
          <a:stretch/>
        </p:blipFill>
        <p:spPr>
          <a:xfrm>
            <a:off x="4821120" y="28440"/>
            <a:ext cx="6516720" cy="2706840"/>
          </a:xfrm>
          <a:prstGeom prst="rect">
            <a:avLst/>
          </a:prstGeom>
          <a:ln w="0">
            <a:noFill/>
          </a:ln>
        </p:spPr>
      </p:pic>
      <p:sp>
        <p:nvSpPr>
          <p:cNvPr id="126" name="Text Box 5"/>
          <p:cNvSpPr/>
          <p:nvPr/>
        </p:nvSpPr>
        <p:spPr>
          <a:xfrm>
            <a:off x="5114520" y="123840"/>
            <a:ext cx="11340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 Box 6"/>
          <p:cNvSpPr/>
          <p:nvPr/>
        </p:nvSpPr>
        <p:spPr>
          <a:xfrm>
            <a:off x="5697360" y="170028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 Box 7"/>
          <p:cNvSpPr/>
          <p:nvPr/>
        </p:nvSpPr>
        <p:spPr>
          <a:xfrm>
            <a:off x="6023160" y="1839960"/>
            <a:ext cx="11340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 Box 8"/>
          <p:cNvSpPr/>
          <p:nvPr/>
        </p:nvSpPr>
        <p:spPr>
          <a:xfrm>
            <a:off x="6310440" y="7632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 Box 9"/>
          <p:cNvSpPr/>
          <p:nvPr/>
        </p:nvSpPr>
        <p:spPr>
          <a:xfrm>
            <a:off x="6639840" y="1805040"/>
            <a:ext cx="11340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 Box 10"/>
          <p:cNvSpPr/>
          <p:nvPr/>
        </p:nvSpPr>
        <p:spPr>
          <a:xfrm>
            <a:off x="6887160" y="1757520"/>
            <a:ext cx="8604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 Box 12"/>
          <p:cNvSpPr/>
          <p:nvPr/>
        </p:nvSpPr>
        <p:spPr>
          <a:xfrm>
            <a:off x="7099200" y="176832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 Box 13"/>
          <p:cNvSpPr/>
          <p:nvPr/>
        </p:nvSpPr>
        <p:spPr>
          <a:xfrm>
            <a:off x="7226280" y="130176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 Box 14"/>
          <p:cNvSpPr/>
          <p:nvPr/>
        </p:nvSpPr>
        <p:spPr>
          <a:xfrm>
            <a:off x="7380360" y="868320"/>
            <a:ext cx="70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 Box 15"/>
          <p:cNvSpPr/>
          <p:nvPr/>
        </p:nvSpPr>
        <p:spPr>
          <a:xfrm>
            <a:off x="7517160" y="142920"/>
            <a:ext cx="70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 Box 16"/>
          <p:cNvSpPr/>
          <p:nvPr/>
        </p:nvSpPr>
        <p:spPr>
          <a:xfrm>
            <a:off x="7597800" y="81432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 Box 17"/>
          <p:cNvSpPr/>
          <p:nvPr/>
        </p:nvSpPr>
        <p:spPr>
          <a:xfrm>
            <a:off x="7766280" y="698400"/>
            <a:ext cx="70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 Box 18"/>
          <p:cNvSpPr/>
          <p:nvPr/>
        </p:nvSpPr>
        <p:spPr>
          <a:xfrm>
            <a:off x="7827120" y="415800"/>
            <a:ext cx="1987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 Box 19"/>
          <p:cNvSpPr/>
          <p:nvPr/>
        </p:nvSpPr>
        <p:spPr>
          <a:xfrm>
            <a:off x="7969320" y="74628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Line 20"/>
          <p:cNvSpPr/>
          <p:nvPr/>
        </p:nvSpPr>
        <p:spPr>
          <a:xfrm>
            <a:off x="7959600" y="1058760"/>
            <a:ext cx="144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 Box 21"/>
          <p:cNvSpPr/>
          <p:nvPr/>
        </p:nvSpPr>
        <p:spPr>
          <a:xfrm>
            <a:off x="8035920" y="59688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 Box 22"/>
          <p:cNvSpPr/>
          <p:nvPr/>
        </p:nvSpPr>
        <p:spPr>
          <a:xfrm>
            <a:off x="8185320" y="46512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Line 23"/>
          <p:cNvSpPr/>
          <p:nvPr/>
        </p:nvSpPr>
        <p:spPr>
          <a:xfrm flipV="1">
            <a:off x="7927920" y="745920"/>
            <a:ext cx="0" cy="549000"/>
          </a:xfrm>
          <a:prstGeom prst="line">
            <a:avLst/>
          </a:prstGeom>
          <a:ln w="19080">
            <a:solidFill>
              <a:srgbClr val="000000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 Box 24"/>
          <p:cNvSpPr/>
          <p:nvPr/>
        </p:nvSpPr>
        <p:spPr>
          <a:xfrm>
            <a:off x="8288280" y="89388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 Box 25"/>
          <p:cNvSpPr/>
          <p:nvPr/>
        </p:nvSpPr>
        <p:spPr>
          <a:xfrm>
            <a:off x="8511120" y="1087560"/>
            <a:ext cx="8604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 Box 26"/>
          <p:cNvSpPr/>
          <p:nvPr/>
        </p:nvSpPr>
        <p:spPr>
          <a:xfrm>
            <a:off x="8826480" y="1633680"/>
            <a:ext cx="997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 Box 27"/>
          <p:cNvSpPr/>
          <p:nvPr/>
        </p:nvSpPr>
        <p:spPr>
          <a:xfrm>
            <a:off x="8947440" y="1290600"/>
            <a:ext cx="70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 Box 28"/>
          <p:cNvSpPr/>
          <p:nvPr/>
        </p:nvSpPr>
        <p:spPr>
          <a:xfrm>
            <a:off x="9133560" y="153828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 Box 29"/>
          <p:cNvSpPr/>
          <p:nvPr/>
        </p:nvSpPr>
        <p:spPr>
          <a:xfrm>
            <a:off x="9403560" y="156060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Line 30"/>
          <p:cNvSpPr/>
          <p:nvPr/>
        </p:nvSpPr>
        <p:spPr>
          <a:xfrm>
            <a:off x="9394920" y="190980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Line 31"/>
          <p:cNvSpPr/>
          <p:nvPr/>
        </p:nvSpPr>
        <p:spPr>
          <a:xfrm>
            <a:off x="9090000" y="1881360"/>
            <a:ext cx="216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Text Box 33"/>
          <p:cNvSpPr/>
          <p:nvPr/>
        </p:nvSpPr>
        <p:spPr>
          <a:xfrm>
            <a:off x="9711000" y="1725480"/>
            <a:ext cx="18504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 Box 34"/>
          <p:cNvSpPr/>
          <p:nvPr/>
        </p:nvSpPr>
        <p:spPr>
          <a:xfrm>
            <a:off x="10031400" y="172260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x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 Box 35"/>
          <p:cNvSpPr/>
          <p:nvPr/>
        </p:nvSpPr>
        <p:spPr>
          <a:xfrm>
            <a:off x="10838160" y="1886040"/>
            <a:ext cx="11340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z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Line 150"/>
          <p:cNvSpPr/>
          <p:nvPr/>
        </p:nvSpPr>
        <p:spPr>
          <a:xfrm>
            <a:off x="10206000" y="2152800"/>
            <a:ext cx="457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 Box 151"/>
          <p:cNvSpPr/>
          <p:nvPr/>
        </p:nvSpPr>
        <p:spPr>
          <a:xfrm>
            <a:off x="10463040" y="179244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Text Box 24"/>
          <p:cNvSpPr/>
          <p:nvPr/>
        </p:nvSpPr>
        <p:spPr>
          <a:xfrm>
            <a:off x="4429080" y="232092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Text Box 17"/>
          <p:cNvSpPr/>
          <p:nvPr/>
        </p:nvSpPr>
        <p:spPr>
          <a:xfrm>
            <a:off x="4429080" y="83664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8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 Box 17"/>
          <p:cNvSpPr/>
          <p:nvPr/>
        </p:nvSpPr>
        <p:spPr>
          <a:xfrm>
            <a:off x="4429080" y="157968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4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Text Box 17"/>
          <p:cNvSpPr/>
          <p:nvPr/>
        </p:nvSpPr>
        <p:spPr>
          <a:xfrm>
            <a:off x="4429080" y="46512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.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Text Box 17"/>
          <p:cNvSpPr/>
          <p:nvPr/>
        </p:nvSpPr>
        <p:spPr>
          <a:xfrm>
            <a:off x="4429080" y="120816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6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Text Box 17"/>
          <p:cNvSpPr/>
          <p:nvPr/>
        </p:nvSpPr>
        <p:spPr>
          <a:xfrm>
            <a:off x="4429080" y="194940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Text Box 19"/>
          <p:cNvSpPr/>
          <p:nvPr/>
        </p:nvSpPr>
        <p:spPr>
          <a:xfrm>
            <a:off x="11198520" y="274788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Line 150"/>
          <p:cNvSpPr/>
          <p:nvPr/>
        </p:nvSpPr>
        <p:spPr>
          <a:xfrm>
            <a:off x="9651960" y="2055960"/>
            <a:ext cx="2746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Text Box 19"/>
          <p:cNvSpPr/>
          <p:nvPr/>
        </p:nvSpPr>
        <p:spPr>
          <a:xfrm>
            <a:off x="38160" y="-63360"/>
            <a:ext cx="269640" cy="42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Text Box 19"/>
          <p:cNvSpPr/>
          <p:nvPr/>
        </p:nvSpPr>
        <p:spPr>
          <a:xfrm>
            <a:off x="4429080" y="-63360"/>
            <a:ext cx="268200" cy="42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Text Box 19"/>
          <p:cNvSpPr/>
          <p:nvPr/>
        </p:nvSpPr>
        <p:spPr>
          <a:xfrm>
            <a:off x="38160" y="3032280"/>
            <a:ext cx="269640" cy="42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8" name="Group 336"/>
          <p:cNvGrpSpPr/>
          <p:nvPr/>
        </p:nvGrpSpPr>
        <p:grpSpPr>
          <a:xfrm>
            <a:off x="465480" y="3233880"/>
            <a:ext cx="153000" cy="801000"/>
            <a:chOff x="465480" y="3233880"/>
            <a:chExt cx="153000" cy="801000"/>
          </a:xfrm>
        </p:grpSpPr>
        <p:sp>
          <p:nvSpPr>
            <p:cNvPr id="169" name="Text Box 124"/>
            <p:cNvSpPr/>
            <p:nvPr/>
          </p:nvSpPr>
          <p:spPr>
            <a:xfrm>
              <a:off x="473760" y="3233880"/>
              <a:ext cx="1364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a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Text Box 152"/>
            <p:cNvSpPr/>
            <p:nvPr/>
          </p:nvSpPr>
          <p:spPr>
            <a:xfrm>
              <a:off x="465480" y="366876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4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1" name="Group 339"/>
          <p:cNvGrpSpPr/>
          <p:nvPr/>
        </p:nvGrpSpPr>
        <p:grpSpPr>
          <a:xfrm>
            <a:off x="846360" y="3233880"/>
            <a:ext cx="153000" cy="801000"/>
            <a:chOff x="846360" y="3233880"/>
            <a:chExt cx="153000" cy="801000"/>
          </a:xfrm>
        </p:grpSpPr>
        <p:sp>
          <p:nvSpPr>
            <p:cNvPr id="172" name="Text Box 125"/>
            <p:cNvSpPr/>
            <p:nvPr/>
          </p:nvSpPr>
          <p:spPr>
            <a:xfrm>
              <a:off x="846360" y="323388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b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Text Box 153"/>
            <p:cNvSpPr/>
            <p:nvPr/>
          </p:nvSpPr>
          <p:spPr>
            <a:xfrm>
              <a:off x="846360" y="366876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4" name="Group 342"/>
          <p:cNvGrpSpPr/>
          <p:nvPr/>
        </p:nvGrpSpPr>
        <p:grpSpPr>
          <a:xfrm>
            <a:off x="1227600" y="3233880"/>
            <a:ext cx="153000" cy="801000"/>
            <a:chOff x="1227600" y="3233880"/>
            <a:chExt cx="153000" cy="801000"/>
          </a:xfrm>
        </p:grpSpPr>
        <p:sp>
          <p:nvSpPr>
            <p:cNvPr id="175" name="Text Box 126"/>
            <p:cNvSpPr/>
            <p:nvPr/>
          </p:nvSpPr>
          <p:spPr>
            <a:xfrm>
              <a:off x="1235880" y="3233880"/>
              <a:ext cx="1364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c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Text Box 154"/>
            <p:cNvSpPr/>
            <p:nvPr/>
          </p:nvSpPr>
          <p:spPr>
            <a:xfrm>
              <a:off x="1227600" y="366876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7" name="Group 345"/>
          <p:cNvGrpSpPr/>
          <p:nvPr/>
        </p:nvGrpSpPr>
        <p:grpSpPr>
          <a:xfrm>
            <a:off x="1609200" y="3233880"/>
            <a:ext cx="305640" cy="801000"/>
            <a:chOff x="1609200" y="3233880"/>
            <a:chExt cx="305640" cy="801000"/>
          </a:xfrm>
        </p:grpSpPr>
        <p:sp>
          <p:nvSpPr>
            <p:cNvPr id="178" name="Text Box 134"/>
            <p:cNvSpPr/>
            <p:nvPr/>
          </p:nvSpPr>
          <p:spPr>
            <a:xfrm>
              <a:off x="1685520" y="323388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ff0000"/>
                  </a:solidFill>
                  <a:latin typeface="Times New Roman"/>
                </a:rPr>
                <a:t>d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Text Box 155"/>
            <p:cNvSpPr/>
            <p:nvPr/>
          </p:nvSpPr>
          <p:spPr>
            <a:xfrm>
              <a:off x="1609200" y="3668760"/>
              <a:ext cx="3056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ff0000"/>
                  </a:solidFill>
                  <a:latin typeface="Times New Roman"/>
                </a:rPr>
                <a:t>48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0" name="Group 348"/>
          <p:cNvGrpSpPr/>
          <p:nvPr/>
        </p:nvGrpSpPr>
        <p:grpSpPr>
          <a:xfrm>
            <a:off x="2144160" y="3233880"/>
            <a:ext cx="305640" cy="801000"/>
            <a:chOff x="2144160" y="3233880"/>
            <a:chExt cx="305640" cy="801000"/>
          </a:xfrm>
        </p:grpSpPr>
        <p:sp>
          <p:nvSpPr>
            <p:cNvPr id="181" name="Text Box 127"/>
            <p:cNvSpPr/>
            <p:nvPr/>
          </p:nvSpPr>
          <p:spPr>
            <a:xfrm>
              <a:off x="2228760" y="3233880"/>
              <a:ext cx="1364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ff0000"/>
                  </a:solidFill>
                  <a:latin typeface="Times New Roman"/>
                </a:rPr>
                <a:t>e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Text Box 156"/>
            <p:cNvSpPr/>
            <p:nvPr/>
          </p:nvSpPr>
          <p:spPr>
            <a:xfrm>
              <a:off x="2144160" y="3668760"/>
              <a:ext cx="3056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ff0000"/>
                  </a:solidFill>
                  <a:latin typeface="Times New Roman"/>
                </a:rPr>
                <a:t>30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3" name="Group 351"/>
          <p:cNvGrpSpPr/>
          <p:nvPr/>
        </p:nvGrpSpPr>
        <p:grpSpPr>
          <a:xfrm>
            <a:off x="2678400" y="3233880"/>
            <a:ext cx="153000" cy="801000"/>
            <a:chOff x="2678400" y="3233880"/>
            <a:chExt cx="153000" cy="801000"/>
          </a:xfrm>
        </p:grpSpPr>
        <p:sp>
          <p:nvSpPr>
            <p:cNvPr id="184" name="Text Box 128"/>
            <p:cNvSpPr/>
            <p:nvPr/>
          </p:nvSpPr>
          <p:spPr>
            <a:xfrm>
              <a:off x="2703240" y="3233880"/>
              <a:ext cx="10296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f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Text Box 157"/>
            <p:cNvSpPr/>
            <p:nvPr/>
          </p:nvSpPr>
          <p:spPr>
            <a:xfrm>
              <a:off x="2678400" y="366876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8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6" name="Group 354"/>
          <p:cNvGrpSpPr/>
          <p:nvPr/>
        </p:nvGrpSpPr>
        <p:grpSpPr>
          <a:xfrm>
            <a:off x="3059640" y="3233880"/>
            <a:ext cx="153000" cy="801000"/>
            <a:chOff x="3059640" y="3233880"/>
            <a:chExt cx="153000" cy="801000"/>
          </a:xfrm>
        </p:grpSpPr>
        <p:sp>
          <p:nvSpPr>
            <p:cNvPr id="187" name="Text Box 129"/>
            <p:cNvSpPr/>
            <p:nvPr/>
          </p:nvSpPr>
          <p:spPr>
            <a:xfrm>
              <a:off x="3059640" y="323388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g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Text Box 158"/>
            <p:cNvSpPr/>
            <p:nvPr/>
          </p:nvSpPr>
          <p:spPr>
            <a:xfrm>
              <a:off x="3059640" y="366876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9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9" name="Group 357"/>
          <p:cNvGrpSpPr/>
          <p:nvPr/>
        </p:nvGrpSpPr>
        <p:grpSpPr>
          <a:xfrm>
            <a:off x="3435120" y="3233880"/>
            <a:ext cx="305640" cy="801000"/>
            <a:chOff x="3435120" y="3233880"/>
            <a:chExt cx="305640" cy="801000"/>
          </a:xfrm>
        </p:grpSpPr>
        <p:sp>
          <p:nvSpPr>
            <p:cNvPr id="190" name="Text Box 130"/>
            <p:cNvSpPr/>
            <p:nvPr/>
          </p:nvSpPr>
          <p:spPr>
            <a:xfrm>
              <a:off x="3511080" y="323388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ff0000"/>
                  </a:solidFill>
                  <a:latin typeface="Times New Roman"/>
                </a:rPr>
                <a:t>h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Text Box 159"/>
            <p:cNvSpPr/>
            <p:nvPr/>
          </p:nvSpPr>
          <p:spPr>
            <a:xfrm>
              <a:off x="3435120" y="3668760"/>
              <a:ext cx="3056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ff0000"/>
                  </a:solidFill>
                  <a:latin typeface="Times New Roman"/>
                </a:rPr>
                <a:t>11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2" name="Group 360"/>
          <p:cNvGrpSpPr/>
          <p:nvPr/>
        </p:nvGrpSpPr>
        <p:grpSpPr>
          <a:xfrm>
            <a:off x="3964320" y="3233880"/>
            <a:ext cx="305640" cy="801000"/>
            <a:chOff x="3964320" y="3233880"/>
            <a:chExt cx="305640" cy="801000"/>
          </a:xfrm>
        </p:grpSpPr>
        <p:sp>
          <p:nvSpPr>
            <p:cNvPr id="193" name="Text Box 131"/>
            <p:cNvSpPr/>
            <p:nvPr/>
          </p:nvSpPr>
          <p:spPr>
            <a:xfrm>
              <a:off x="4074120" y="3233880"/>
              <a:ext cx="860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ff0000"/>
                  </a:solidFill>
                  <a:latin typeface="Times New Roman"/>
                </a:rPr>
                <a:t>i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Text Box 160"/>
            <p:cNvSpPr/>
            <p:nvPr/>
          </p:nvSpPr>
          <p:spPr>
            <a:xfrm>
              <a:off x="3964320" y="3668760"/>
              <a:ext cx="3056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ff0000"/>
                  </a:solidFill>
                  <a:latin typeface="Times New Roman"/>
                </a:rPr>
                <a:t>50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5" name="Group 363"/>
          <p:cNvGrpSpPr/>
          <p:nvPr/>
        </p:nvGrpSpPr>
        <p:grpSpPr>
          <a:xfrm>
            <a:off x="4499280" y="3233880"/>
            <a:ext cx="305640" cy="801000"/>
            <a:chOff x="4499280" y="3233880"/>
            <a:chExt cx="305640" cy="801000"/>
          </a:xfrm>
        </p:grpSpPr>
        <p:sp>
          <p:nvSpPr>
            <p:cNvPr id="196" name="Text Box 132"/>
            <p:cNvSpPr/>
            <p:nvPr/>
          </p:nvSpPr>
          <p:spPr>
            <a:xfrm>
              <a:off x="4609080" y="3233880"/>
              <a:ext cx="860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ff0000"/>
                  </a:solidFill>
                  <a:latin typeface="Times New Roman"/>
                </a:rPr>
                <a:t>j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Text Box 161"/>
            <p:cNvSpPr/>
            <p:nvPr/>
          </p:nvSpPr>
          <p:spPr>
            <a:xfrm>
              <a:off x="4499280" y="3668760"/>
              <a:ext cx="3056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ff0000"/>
                  </a:solidFill>
                  <a:latin typeface="Times New Roman"/>
                </a:rPr>
                <a:t>55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8" name="Group 366"/>
          <p:cNvGrpSpPr/>
          <p:nvPr/>
        </p:nvGrpSpPr>
        <p:grpSpPr>
          <a:xfrm>
            <a:off x="5034240" y="3233880"/>
            <a:ext cx="305640" cy="801000"/>
            <a:chOff x="5034240" y="3233880"/>
            <a:chExt cx="305640" cy="801000"/>
          </a:xfrm>
        </p:grpSpPr>
        <p:sp>
          <p:nvSpPr>
            <p:cNvPr id="199" name="Text Box 133"/>
            <p:cNvSpPr/>
            <p:nvPr/>
          </p:nvSpPr>
          <p:spPr>
            <a:xfrm>
              <a:off x="5110200" y="323388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ff0000"/>
                  </a:solidFill>
                  <a:latin typeface="Times New Roman"/>
                </a:rPr>
                <a:t>k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Text Box 162"/>
            <p:cNvSpPr/>
            <p:nvPr/>
          </p:nvSpPr>
          <p:spPr>
            <a:xfrm>
              <a:off x="5034240" y="3668760"/>
              <a:ext cx="3056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ff0000"/>
                  </a:solidFill>
                  <a:latin typeface="Times New Roman"/>
                </a:rPr>
                <a:t>49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1" name="Group 369"/>
          <p:cNvGrpSpPr/>
          <p:nvPr/>
        </p:nvGrpSpPr>
        <p:grpSpPr>
          <a:xfrm>
            <a:off x="5568480" y="3233880"/>
            <a:ext cx="305640" cy="801000"/>
            <a:chOff x="5568480" y="3233880"/>
            <a:chExt cx="305640" cy="801000"/>
          </a:xfrm>
        </p:grpSpPr>
        <p:sp>
          <p:nvSpPr>
            <p:cNvPr id="202" name="Text Box 135"/>
            <p:cNvSpPr/>
            <p:nvPr/>
          </p:nvSpPr>
          <p:spPr>
            <a:xfrm>
              <a:off x="5678280" y="3233880"/>
              <a:ext cx="860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ff0000"/>
                  </a:solidFill>
                  <a:latin typeface="Times New Roman"/>
                </a:rPr>
                <a:t>l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Text Box 163"/>
            <p:cNvSpPr/>
            <p:nvPr/>
          </p:nvSpPr>
          <p:spPr>
            <a:xfrm>
              <a:off x="5568480" y="3668760"/>
              <a:ext cx="3056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ff0000"/>
                  </a:solidFill>
                  <a:latin typeface="Times New Roman"/>
                </a:rPr>
                <a:t>25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4" name="Group 372"/>
          <p:cNvGrpSpPr/>
          <p:nvPr/>
        </p:nvGrpSpPr>
        <p:grpSpPr>
          <a:xfrm>
            <a:off x="6103080" y="3233880"/>
            <a:ext cx="238320" cy="801000"/>
            <a:chOff x="6103080" y="3233880"/>
            <a:chExt cx="238320" cy="801000"/>
          </a:xfrm>
        </p:grpSpPr>
        <p:sp>
          <p:nvSpPr>
            <p:cNvPr id="205" name="Text Box 136"/>
            <p:cNvSpPr/>
            <p:nvPr/>
          </p:nvSpPr>
          <p:spPr>
            <a:xfrm>
              <a:off x="6103080" y="3233880"/>
              <a:ext cx="2383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m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Text Box 164"/>
            <p:cNvSpPr/>
            <p:nvPr/>
          </p:nvSpPr>
          <p:spPr>
            <a:xfrm>
              <a:off x="6145560" y="366876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9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7" name="Group 375"/>
          <p:cNvGrpSpPr/>
          <p:nvPr/>
        </p:nvGrpSpPr>
        <p:grpSpPr>
          <a:xfrm>
            <a:off x="6569280" y="3233880"/>
            <a:ext cx="153000" cy="801000"/>
            <a:chOff x="6569280" y="3233880"/>
            <a:chExt cx="153000" cy="801000"/>
          </a:xfrm>
        </p:grpSpPr>
        <p:sp>
          <p:nvSpPr>
            <p:cNvPr id="208" name="Text Box 137"/>
            <p:cNvSpPr/>
            <p:nvPr/>
          </p:nvSpPr>
          <p:spPr>
            <a:xfrm>
              <a:off x="6569280" y="323388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n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Text Box 165"/>
            <p:cNvSpPr/>
            <p:nvPr/>
          </p:nvSpPr>
          <p:spPr>
            <a:xfrm>
              <a:off x="6569280" y="366876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4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0" name="Group 378"/>
          <p:cNvGrpSpPr/>
          <p:nvPr/>
        </p:nvGrpSpPr>
        <p:grpSpPr>
          <a:xfrm>
            <a:off x="6950520" y="3233880"/>
            <a:ext cx="153000" cy="801000"/>
            <a:chOff x="6950520" y="3233880"/>
            <a:chExt cx="153000" cy="801000"/>
          </a:xfrm>
        </p:grpSpPr>
        <p:sp>
          <p:nvSpPr>
            <p:cNvPr id="211" name="Text Box 138"/>
            <p:cNvSpPr/>
            <p:nvPr/>
          </p:nvSpPr>
          <p:spPr>
            <a:xfrm>
              <a:off x="6950520" y="323388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o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Text Box 166"/>
            <p:cNvSpPr/>
            <p:nvPr/>
          </p:nvSpPr>
          <p:spPr>
            <a:xfrm>
              <a:off x="6950520" y="366876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9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3" name="Group 381"/>
          <p:cNvGrpSpPr/>
          <p:nvPr/>
        </p:nvGrpSpPr>
        <p:grpSpPr>
          <a:xfrm>
            <a:off x="7332120" y="3233880"/>
            <a:ext cx="305640" cy="801000"/>
            <a:chOff x="7332120" y="3233880"/>
            <a:chExt cx="305640" cy="801000"/>
          </a:xfrm>
        </p:grpSpPr>
        <p:sp>
          <p:nvSpPr>
            <p:cNvPr id="214" name="Text Box 139"/>
            <p:cNvSpPr/>
            <p:nvPr/>
          </p:nvSpPr>
          <p:spPr>
            <a:xfrm>
              <a:off x="7408440" y="323388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ff0000"/>
                  </a:solidFill>
                  <a:latin typeface="Times New Roman"/>
                </a:rPr>
                <a:t>p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Text Box 167"/>
            <p:cNvSpPr/>
            <p:nvPr/>
          </p:nvSpPr>
          <p:spPr>
            <a:xfrm>
              <a:off x="7332120" y="3668760"/>
              <a:ext cx="3056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ff0000"/>
                  </a:solidFill>
                  <a:latin typeface="Times New Roman"/>
                </a:rPr>
                <a:t>20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6" name="Group 384"/>
          <p:cNvGrpSpPr/>
          <p:nvPr/>
        </p:nvGrpSpPr>
        <p:grpSpPr>
          <a:xfrm>
            <a:off x="7866360" y="3233880"/>
            <a:ext cx="153000" cy="801000"/>
            <a:chOff x="7866360" y="3233880"/>
            <a:chExt cx="153000" cy="801000"/>
          </a:xfrm>
        </p:grpSpPr>
        <p:sp>
          <p:nvSpPr>
            <p:cNvPr id="217" name="Text Box 147"/>
            <p:cNvSpPr/>
            <p:nvPr/>
          </p:nvSpPr>
          <p:spPr>
            <a:xfrm>
              <a:off x="7866360" y="323388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q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Text Box 168"/>
            <p:cNvSpPr/>
            <p:nvPr/>
          </p:nvSpPr>
          <p:spPr>
            <a:xfrm>
              <a:off x="7866360" y="366876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8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9" name="Group 387"/>
          <p:cNvGrpSpPr/>
          <p:nvPr/>
        </p:nvGrpSpPr>
        <p:grpSpPr>
          <a:xfrm>
            <a:off x="8247600" y="3233880"/>
            <a:ext cx="153000" cy="801000"/>
            <a:chOff x="8247600" y="3233880"/>
            <a:chExt cx="153000" cy="801000"/>
          </a:xfrm>
        </p:grpSpPr>
        <p:sp>
          <p:nvSpPr>
            <p:cNvPr id="220" name="Text Box 140"/>
            <p:cNvSpPr/>
            <p:nvPr/>
          </p:nvSpPr>
          <p:spPr>
            <a:xfrm>
              <a:off x="8272800" y="3233880"/>
              <a:ext cx="10296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r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Text Box 169"/>
            <p:cNvSpPr/>
            <p:nvPr/>
          </p:nvSpPr>
          <p:spPr>
            <a:xfrm>
              <a:off x="8247600" y="366876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7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2" name="Group 390"/>
          <p:cNvGrpSpPr/>
          <p:nvPr/>
        </p:nvGrpSpPr>
        <p:grpSpPr>
          <a:xfrm>
            <a:off x="8628480" y="3233880"/>
            <a:ext cx="153000" cy="801000"/>
            <a:chOff x="8628480" y="3233880"/>
            <a:chExt cx="153000" cy="801000"/>
          </a:xfrm>
        </p:grpSpPr>
        <p:sp>
          <p:nvSpPr>
            <p:cNvPr id="223" name="Text Box 141"/>
            <p:cNvSpPr/>
            <p:nvPr/>
          </p:nvSpPr>
          <p:spPr>
            <a:xfrm>
              <a:off x="8645040" y="3233880"/>
              <a:ext cx="1195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s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Text Box 170"/>
            <p:cNvSpPr/>
            <p:nvPr/>
          </p:nvSpPr>
          <p:spPr>
            <a:xfrm>
              <a:off x="8628480" y="366876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5" name="Group 393"/>
          <p:cNvGrpSpPr/>
          <p:nvPr/>
        </p:nvGrpSpPr>
        <p:grpSpPr>
          <a:xfrm>
            <a:off x="9009360" y="3233880"/>
            <a:ext cx="153000" cy="801000"/>
            <a:chOff x="9009360" y="3233880"/>
            <a:chExt cx="153000" cy="801000"/>
          </a:xfrm>
        </p:grpSpPr>
        <p:sp>
          <p:nvSpPr>
            <p:cNvPr id="226" name="Text Box 142"/>
            <p:cNvSpPr/>
            <p:nvPr/>
          </p:nvSpPr>
          <p:spPr>
            <a:xfrm>
              <a:off x="9042840" y="3233880"/>
              <a:ext cx="860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t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Text Box 171"/>
            <p:cNvSpPr/>
            <p:nvPr/>
          </p:nvSpPr>
          <p:spPr>
            <a:xfrm>
              <a:off x="9009360" y="366876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3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8" name="Group 396"/>
          <p:cNvGrpSpPr/>
          <p:nvPr/>
        </p:nvGrpSpPr>
        <p:grpSpPr>
          <a:xfrm>
            <a:off x="9390600" y="3233880"/>
            <a:ext cx="153000" cy="801000"/>
            <a:chOff x="9390600" y="3233880"/>
            <a:chExt cx="153000" cy="801000"/>
          </a:xfrm>
        </p:grpSpPr>
        <p:sp>
          <p:nvSpPr>
            <p:cNvPr id="229" name="Text Box 143"/>
            <p:cNvSpPr/>
            <p:nvPr/>
          </p:nvSpPr>
          <p:spPr>
            <a:xfrm>
              <a:off x="9390600" y="323388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u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Text Box 172"/>
            <p:cNvSpPr/>
            <p:nvPr/>
          </p:nvSpPr>
          <p:spPr>
            <a:xfrm>
              <a:off x="9390600" y="366876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31" name="Group 399"/>
          <p:cNvGrpSpPr/>
          <p:nvPr/>
        </p:nvGrpSpPr>
        <p:grpSpPr>
          <a:xfrm>
            <a:off x="9772560" y="3233880"/>
            <a:ext cx="153000" cy="801000"/>
            <a:chOff x="9772560" y="3233880"/>
            <a:chExt cx="153000" cy="801000"/>
          </a:xfrm>
        </p:grpSpPr>
        <p:sp>
          <p:nvSpPr>
            <p:cNvPr id="232" name="Text Box 144"/>
            <p:cNvSpPr/>
            <p:nvPr/>
          </p:nvSpPr>
          <p:spPr>
            <a:xfrm>
              <a:off x="9772560" y="323388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v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Text Box 173"/>
            <p:cNvSpPr/>
            <p:nvPr/>
          </p:nvSpPr>
          <p:spPr>
            <a:xfrm>
              <a:off x="9772560" y="366876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34" name="Group 402"/>
          <p:cNvGrpSpPr/>
          <p:nvPr/>
        </p:nvGrpSpPr>
        <p:grpSpPr>
          <a:xfrm>
            <a:off x="10154520" y="3233880"/>
            <a:ext cx="220320" cy="801000"/>
            <a:chOff x="10154520" y="3233880"/>
            <a:chExt cx="220320" cy="801000"/>
          </a:xfrm>
        </p:grpSpPr>
        <p:sp>
          <p:nvSpPr>
            <p:cNvPr id="235" name="Text Box 145"/>
            <p:cNvSpPr/>
            <p:nvPr/>
          </p:nvSpPr>
          <p:spPr>
            <a:xfrm>
              <a:off x="10154520" y="3233880"/>
              <a:ext cx="2203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w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Text Box 174"/>
            <p:cNvSpPr/>
            <p:nvPr/>
          </p:nvSpPr>
          <p:spPr>
            <a:xfrm>
              <a:off x="10188360" y="366876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37" name="Group 405"/>
          <p:cNvGrpSpPr/>
          <p:nvPr/>
        </p:nvGrpSpPr>
        <p:grpSpPr>
          <a:xfrm>
            <a:off x="10603440" y="3233880"/>
            <a:ext cx="153000" cy="801000"/>
            <a:chOff x="10603440" y="3233880"/>
            <a:chExt cx="153000" cy="801000"/>
          </a:xfrm>
        </p:grpSpPr>
        <p:sp>
          <p:nvSpPr>
            <p:cNvPr id="238" name="Text Box 146"/>
            <p:cNvSpPr/>
            <p:nvPr/>
          </p:nvSpPr>
          <p:spPr>
            <a:xfrm>
              <a:off x="10603440" y="323388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x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Text Box 175"/>
            <p:cNvSpPr/>
            <p:nvPr/>
          </p:nvSpPr>
          <p:spPr>
            <a:xfrm>
              <a:off x="10603440" y="366876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40" name="Group 408"/>
          <p:cNvGrpSpPr/>
          <p:nvPr/>
        </p:nvGrpSpPr>
        <p:grpSpPr>
          <a:xfrm>
            <a:off x="10990440" y="3233880"/>
            <a:ext cx="153360" cy="801000"/>
            <a:chOff x="10990440" y="3233880"/>
            <a:chExt cx="153360" cy="801000"/>
          </a:xfrm>
        </p:grpSpPr>
        <p:sp>
          <p:nvSpPr>
            <p:cNvPr id="241" name="Text Box 148"/>
            <p:cNvSpPr/>
            <p:nvPr/>
          </p:nvSpPr>
          <p:spPr>
            <a:xfrm>
              <a:off x="10990800" y="323388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y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Text Box 176"/>
            <p:cNvSpPr/>
            <p:nvPr/>
          </p:nvSpPr>
          <p:spPr>
            <a:xfrm>
              <a:off x="10990440" y="366876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43" name="Group 411"/>
          <p:cNvGrpSpPr/>
          <p:nvPr/>
        </p:nvGrpSpPr>
        <p:grpSpPr>
          <a:xfrm>
            <a:off x="11377800" y="3233880"/>
            <a:ext cx="153000" cy="801000"/>
            <a:chOff x="11377800" y="3233880"/>
            <a:chExt cx="153000" cy="801000"/>
          </a:xfrm>
        </p:grpSpPr>
        <p:sp>
          <p:nvSpPr>
            <p:cNvPr id="244" name="Text Box 149"/>
            <p:cNvSpPr/>
            <p:nvPr/>
          </p:nvSpPr>
          <p:spPr>
            <a:xfrm>
              <a:off x="11386080" y="3233880"/>
              <a:ext cx="13644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z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Text Box 177"/>
            <p:cNvSpPr/>
            <p:nvPr/>
          </p:nvSpPr>
          <p:spPr>
            <a:xfrm>
              <a:off x="11377800" y="3668760"/>
              <a:ext cx="1530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398520"/>
                  <a:tab algn="l" pos="797040"/>
                  <a:tab algn="l" pos="1195560"/>
                  <a:tab algn="l" pos="1593720"/>
                  <a:tab algn="l" pos="1992240"/>
                  <a:tab algn="l" pos="2390760"/>
                  <a:tab algn="l" pos="2789280"/>
                  <a:tab algn="l" pos="3187800"/>
                  <a:tab algn="l" pos="3586320"/>
                  <a:tab algn="l" pos="3984480"/>
                  <a:tab algn="l" pos="4383000"/>
                  <a:tab algn="l" pos="4781520"/>
                  <a:tab algn="l" pos="5180040"/>
                  <a:tab algn="l" pos="5578560"/>
                  <a:tab algn="l" pos="5977080"/>
                  <a:tab algn="l" pos="6375240"/>
                  <a:tab algn="l" pos="6773760"/>
                  <a:tab algn="l" pos="7172280"/>
                  <a:tab algn="l" pos="7570800"/>
                  <a:tab algn="l" pos="796932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6" name="Rectangle 414"/>
          <p:cNvSpPr/>
          <p:nvPr/>
        </p:nvSpPr>
        <p:spPr>
          <a:xfrm>
            <a:off x="358920" y="3233880"/>
            <a:ext cx="11298240" cy="8301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Rectangle 415"/>
          <p:cNvSpPr/>
          <p:nvPr/>
        </p:nvSpPr>
        <p:spPr>
          <a:xfrm>
            <a:off x="4835520" y="63360"/>
            <a:ext cx="6504120" cy="26798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Text Box 19"/>
          <p:cNvSpPr/>
          <p:nvPr/>
        </p:nvSpPr>
        <p:spPr>
          <a:xfrm>
            <a:off x="1016640" y="12600"/>
            <a:ext cx="355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Text Box 19"/>
          <p:cNvSpPr/>
          <p:nvPr/>
        </p:nvSpPr>
        <p:spPr>
          <a:xfrm>
            <a:off x="9456480" y="50760"/>
            <a:ext cx="18007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S1/2R3Pr1a-z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Rectangle 418"/>
          <p:cNvSpPr/>
          <p:nvPr/>
        </p:nvSpPr>
        <p:spPr>
          <a:xfrm>
            <a:off x="195120" y="4181400"/>
            <a:ext cx="11336400" cy="222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398520"/>
                <a:tab algn="l" pos="797040"/>
                <a:tab algn="l" pos="1195560"/>
                <a:tab algn="l" pos="1593720"/>
                <a:tab algn="l" pos="1992240"/>
                <a:tab algn="l" pos="2390760"/>
                <a:tab algn="l" pos="2789280"/>
                <a:tab algn="l" pos="3187800"/>
                <a:tab algn="l" pos="3586320"/>
                <a:tab algn="l" pos="3984480"/>
                <a:tab algn="l" pos="4383000"/>
                <a:tab algn="l" pos="4781520"/>
                <a:tab algn="l" pos="5180040"/>
                <a:tab algn="l" pos="5578560"/>
                <a:tab algn="l" pos="5977080"/>
                <a:tab algn="l" pos="6375240"/>
                <a:tab algn="l" pos="6773760"/>
                <a:tab algn="l" pos="7172280"/>
                <a:tab algn="l" pos="7570800"/>
                <a:tab algn="l" pos="796932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3. Isolation of glycosylated peptides from the pronase digestion of ANS1/2-R3. </a:t>
            </a:r>
            <a:r>
              <a:rPr b="1" i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:</a:t>
            </a: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ze exclusion chromatography of pronase-digested ANS1/2-R3. The blue line and numbers indicate protein (Abs</a:t>
            </a:r>
            <a:r>
              <a:rPr b="0" lang="en-US" sz="2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30</a:t>
            </a: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; the red line and numbers indicate glycosylations that reacted with phenol-sulfate (Abs</a:t>
            </a:r>
            <a:r>
              <a:rPr b="0" lang="en-US" sz="2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490</a:t>
            </a: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. Note the glycosylations are all in fraction 1 (Pr1). </a:t>
            </a:r>
            <a:r>
              <a:rPr b="1" i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:</a:t>
            </a: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RP-HPLC chromatogram (Abs</a:t>
            </a:r>
            <a:r>
              <a:rPr b="0" lang="en-US" sz="2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20</a:t>
            </a: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v. min) showing the separation of the size exclusion fraction 1 (ANS1/2R3-Pr1) into 26 parts, labeled a to z. The numbers at the right indicate percent buffer B in the gradient. </a:t>
            </a:r>
            <a:r>
              <a:rPr b="1" i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:</a:t>
            </a: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able showing the Abs</a:t>
            </a:r>
            <a:r>
              <a:rPr b="0" lang="en-US" sz="2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490</a:t>
            </a: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x 10</a:t>
            </a:r>
            <a:r>
              <a:rPr b="0" lang="en-US" sz="2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3</a:t>
            </a: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of each RP-HPLC fraction. Fractions positive for glycosylation are shown in red and were characterized by N-terminal sequencing.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7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3-15T14:27:50Z</dcterms:created>
  <dc:creator>James Simmer</dc:creator>
  <dc:description/>
  <dc:language>en-US</dc:language>
  <cp:lastModifiedBy>James Simmer</cp:lastModifiedBy>
  <cp:lastPrinted>2010-03-04T14:57:28Z</cp:lastPrinted>
  <dcterms:modified xsi:type="dcterms:W3CDTF">2011-01-31T16:24:38Z</dcterms:modified>
  <cp:revision>19</cp:revision>
  <dc:subject/>
  <dc:title>Slide 1</dc:title>
</cp:coreProperties>
</file>